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8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50FE3-59CC-44AB-91A5-91C3A3ACE642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3D16B-751D-4104-84C9-B3ABFB69E9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16950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50FE3-59CC-44AB-91A5-91C3A3ACE642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3D16B-751D-4104-84C9-B3ABFB69E9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27106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50FE3-59CC-44AB-91A5-91C3A3ACE642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3D16B-751D-4104-84C9-B3ABFB69E9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05770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50FE3-59CC-44AB-91A5-91C3A3ACE642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3D16B-751D-4104-84C9-B3ABFB69E9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37132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50FE3-59CC-44AB-91A5-91C3A3ACE642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3D16B-751D-4104-84C9-B3ABFB69E9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352998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50FE3-59CC-44AB-91A5-91C3A3ACE642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3D16B-751D-4104-84C9-B3ABFB69E9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22852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50FE3-59CC-44AB-91A5-91C3A3ACE642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3D16B-751D-4104-84C9-B3ABFB69E9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22558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50FE3-59CC-44AB-91A5-91C3A3ACE642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3D16B-751D-4104-84C9-B3ABFB69E9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12496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50FE3-59CC-44AB-91A5-91C3A3ACE642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3D16B-751D-4104-84C9-B3ABFB69E9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00689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50FE3-59CC-44AB-91A5-91C3A3ACE642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3D16B-751D-4104-84C9-B3ABFB69E9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83313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50FE3-59CC-44AB-91A5-91C3A3ACE642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3D16B-751D-4104-84C9-B3ABFB69E9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27676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650FE3-59CC-44AB-91A5-91C3A3ACE642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93D16B-751D-4104-84C9-B3ABFB69E9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66786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-1" y="-1"/>
            <a:ext cx="24026901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TW" altLang="en-US"/>
          </a:p>
        </p:txBody>
      </p:sp>
      <p:graphicFrame>
        <p:nvGraphicFramePr>
          <p:cNvPr id="5" name="物件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9375127"/>
              </p:ext>
            </p:extLst>
          </p:nvPr>
        </p:nvGraphicFramePr>
        <p:xfrm>
          <a:off x="1436625" y="144558"/>
          <a:ext cx="9133503" cy="46741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r:id="rId3" imgW="7452000" imgH="3816000" progId="Prism5.Document">
                  <p:embed/>
                </p:oleObj>
              </mc:Choice>
              <mc:Fallback>
                <p:oleObj r:id="rId3" imgW="7452000" imgH="3816000" progId="Prism5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36625" y="144558"/>
                        <a:ext cx="9133503" cy="4674107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矩形 1"/>
          <p:cNvSpPr/>
          <p:nvPr/>
        </p:nvSpPr>
        <p:spPr>
          <a:xfrm>
            <a:off x="1672204" y="4818665"/>
            <a:ext cx="8897923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TW" b="1" dirty="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Figure S1. Distribution of plant species conserved </a:t>
            </a:r>
            <a:r>
              <a:rPr lang="en-US" altLang="zh-TW" b="1" dirty="0" err="1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miRNA</a:t>
            </a:r>
            <a:r>
              <a:rPr lang="en-US" altLang="zh-TW" b="1" dirty="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 </a:t>
            </a:r>
            <a:r>
              <a:rPr lang="en-US" altLang="zh-TW" b="1" dirty="0" smtClean="0"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homology</a:t>
            </a:r>
          </a:p>
          <a:p>
            <a:pPr>
              <a:lnSpc>
                <a:spcPct val="150000"/>
              </a:lnSpc>
            </a:pP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mary of distributed conserved </a:t>
            </a:r>
            <a:r>
              <a:rPr lang="en-US" altLang="zh-TW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NA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tch in </a:t>
            </a:r>
            <a:r>
              <a:rPr lang="en-US" altLang="zh-TW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Base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 species, from control (white bar) and </a:t>
            </a:r>
            <a:r>
              <a:rPr lang="en-US" altLang="zh-TW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P-</a:t>
            </a:r>
            <a:r>
              <a:rPr lang="en-US" altLang="zh-TW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</a:t>
            </a:r>
            <a:r>
              <a:rPr lang="en-US" altLang="zh-TW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lue bar), respectively.</a:t>
            </a:r>
            <a:endParaRPr lang="zh-TW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TW" altLang="en-US" b="1" dirty="0"/>
          </a:p>
        </p:txBody>
      </p:sp>
    </p:spTree>
    <p:extLst>
      <p:ext uri="{BB962C8B-B14F-4D97-AF65-F5344CB8AC3E}">
        <p14:creationId xmlns:p14="http://schemas.microsoft.com/office/powerpoint/2010/main" val="800646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36</Words>
  <Application>Microsoft Office PowerPoint</Application>
  <PresentationFormat>寬螢幕</PresentationFormat>
  <Paragraphs>2</Paragraphs>
  <Slides>1</Slides>
  <Notes>0</Notes>
  <HiddenSlides>0</HiddenSlides>
  <MMClips>0</MMClips>
  <ScaleCrop>false</ScaleCrop>
  <HeadingPairs>
    <vt:vector size="8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9" baseType="lpstr">
      <vt:lpstr>Arial Unicode MS</vt:lpstr>
      <vt:lpstr>新細明體</vt:lpstr>
      <vt:lpstr>Arial</vt:lpstr>
      <vt:lpstr>Calibri</vt:lpstr>
      <vt:lpstr>Calibri Light</vt:lpstr>
      <vt:lpstr>Times New Roman</vt:lpstr>
      <vt:lpstr>Office 佈景主題</vt:lpstr>
      <vt:lpstr>Prism5.Document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wishstar2004</dc:creator>
  <cp:lastModifiedBy>水月</cp:lastModifiedBy>
  <cp:revision>3</cp:revision>
  <dcterms:created xsi:type="dcterms:W3CDTF">2013-08-22T07:30:11Z</dcterms:created>
  <dcterms:modified xsi:type="dcterms:W3CDTF">2013-08-22T11:52:35Z</dcterms:modified>
</cp:coreProperties>
</file>